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308" r:id="rId3"/>
    <p:sldId id="309" r:id="rId4"/>
    <p:sldId id="310" r:id="rId5"/>
    <p:sldId id="311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3B7694E-9B31-4718-8A8A-887EDC97A829}" v="68" dt="2024-03-16T08:03:59.9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0" autoAdjust="0"/>
    <p:restoredTop sz="94660"/>
  </p:normalViewPr>
  <p:slideViewPr>
    <p:cSldViewPr snapToGrid="0">
      <p:cViewPr>
        <p:scale>
          <a:sx n="100" d="100"/>
          <a:sy n="100" d="100"/>
        </p:scale>
        <p:origin x="-24" y="9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박정우" userId="15c4398f-02bf-4106-9135-a1bc85437f64" providerId="ADAL" clId="{13B7694E-9B31-4718-8A8A-887EDC97A829}"/>
    <pc:docChg chg="custSel delSld modSld">
      <pc:chgData name="박정우" userId="15c4398f-02bf-4106-9135-a1bc85437f64" providerId="ADAL" clId="{13B7694E-9B31-4718-8A8A-887EDC97A829}" dt="2024-03-16T08:04:04.348" v="223" actId="1076"/>
      <pc:docMkLst>
        <pc:docMk/>
      </pc:docMkLst>
      <pc:sldChg chg="del">
        <pc:chgData name="박정우" userId="15c4398f-02bf-4106-9135-a1bc85437f64" providerId="ADAL" clId="{13B7694E-9B31-4718-8A8A-887EDC97A829}" dt="2024-03-16T07:20:45.739" v="206" actId="47"/>
        <pc:sldMkLst>
          <pc:docMk/>
          <pc:sldMk cId="4033493990" sldId="307"/>
        </pc:sldMkLst>
      </pc:sldChg>
      <pc:sldChg chg="addSp delSp modSp mod">
        <pc:chgData name="박정우" userId="15c4398f-02bf-4106-9135-a1bc85437f64" providerId="ADAL" clId="{13B7694E-9B31-4718-8A8A-887EDC97A829}" dt="2024-03-16T07:12:52.192" v="101" actId="6549"/>
        <pc:sldMkLst>
          <pc:docMk/>
          <pc:sldMk cId="2220921483" sldId="308"/>
        </pc:sldMkLst>
        <pc:spChg chg="mod">
          <ac:chgData name="박정우" userId="15c4398f-02bf-4106-9135-a1bc85437f64" providerId="ADAL" clId="{13B7694E-9B31-4718-8A8A-887EDC97A829}" dt="2024-03-16T07:06:43.861" v="8" actId="6549"/>
          <ac:spMkLst>
            <pc:docMk/>
            <pc:sldMk cId="2220921483" sldId="308"/>
            <ac:spMk id="3" creationId="{84CC1317-8919-1C5F-3AC0-766AF593CEA2}"/>
          </ac:spMkLst>
        </pc:spChg>
        <pc:spChg chg="add mod">
          <ac:chgData name="박정우" userId="15c4398f-02bf-4106-9135-a1bc85437f64" providerId="ADAL" clId="{13B7694E-9B31-4718-8A8A-887EDC97A829}" dt="2024-03-16T07:07:35.993" v="11" actId="1076"/>
          <ac:spMkLst>
            <pc:docMk/>
            <pc:sldMk cId="2220921483" sldId="308"/>
            <ac:spMk id="6" creationId="{8D2B64D6-EACD-5FB0-1410-7F9A29D0D664}"/>
          </ac:spMkLst>
        </pc:spChg>
        <pc:spChg chg="add del mod">
          <ac:chgData name="박정우" userId="15c4398f-02bf-4106-9135-a1bc85437f64" providerId="ADAL" clId="{13B7694E-9B31-4718-8A8A-887EDC97A829}" dt="2024-03-16T07:09:18.542" v="42" actId="478"/>
          <ac:spMkLst>
            <pc:docMk/>
            <pc:sldMk cId="2220921483" sldId="308"/>
            <ac:spMk id="7" creationId="{3698B174-267F-CBD4-D0B2-3BB69EBE304D}"/>
          </ac:spMkLst>
        </pc:spChg>
        <pc:spChg chg="add mod">
          <ac:chgData name="박정우" userId="15c4398f-02bf-4106-9135-a1bc85437f64" providerId="ADAL" clId="{13B7694E-9B31-4718-8A8A-887EDC97A829}" dt="2024-03-16T07:10:04.701" v="55" actId="1076"/>
          <ac:spMkLst>
            <pc:docMk/>
            <pc:sldMk cId="2220921483" sldId="308"/>
            <ac:spMk id="8" creationId="{FD35525B-7AD7-C9A8-2EC8-D36455CE8ACE}"/>
          </ac:spMkLst>
        </pc:spChg>
        <pc:spChg chg="add del mod">
          <ac:chgData name="박정우" userId="15c4398f-02bf-4106-9135-a1bc85437f64" providerId="ADAL" clId="{13B7694E-9B31-4718-8A8A-887EDC97A829}" dt="2024-03-16T07:09:35.154" v="46" actId="478"/>
          <ac:spMkLst>
            <pc:docMk/>
            <pc:sldMk cId="2220921483" sldId="308"/>
            <ac:spMk id="10" creationId="{7E5362DA-3234-DEB6-C133-35A935E44C89}"/>
          </ac:spMkLst>
        </pc:spChg>
        <pc:spChg chg="add mod">
          <ac:chgData name="박정우" userId="15c4398f-02bf-4106-9135-a1bc85437f64" providerId="ADAL" clId="{13B7694E-9B31-4718-8A8A-887EDC97A829}" dt="2024-03-16T07:10:02.586" v="54" actId="1076"/>
          <ac:spMkLst>
            <pc:docMk/>
            <pc:sldMk cId="2220921483" sldId="308"/>
            <ac:spMk id="12" creationId="{2A0A594F-28FA-7241-A4A1-64B56AF6C6B2}"/>
          </ac:spMkLst>
        </pc:spChg>
        <pc:spChg chg="add mod">
          <ac:chgData name="박정우" userId="15c4398f-02bf-4106-9135-a1bc85437f64" providerId="ADAL" clId="{13B7694E-9B31-4718-8A8A-887EDC97A829}" dt="2024-03-16T07:10:17.460" v="57" actId="1076"/>
          <ac:spMkLst>
            <pc:docMk/>
            <pc:sldMk cId="2220921483" sldId="308"/>
            <ac:spMk id="13" creationId="{23A7333D-BFB4-7E0C-D2F7-E0D1FC4B2358}"/>
          </ac:spMkLst>
        </pc:spChg>
        <pc:spChg chg="add mod">
          <ac:chgData name="박정우" userId="15c4398f-02bf-4106-9135-a1bc85437f64" providerId="ADAL" clId="{13B7694E-9B31-4718-8A8A-887EDC97A829}" dt="2024-03-16T07:10:23.101" v="59" actId="1076"/>
          <ac:spMkLst>
            <pc:docMk/>
            <pc:sldMk cId="2220921483" sldId="308"/>
            <ac:spMk id="14" creationId="{EFE44549-5DDE-1835-C3B6-D5337E759893}"/>
          </ac:spMkLst>
        </pc:spChg>
        <pc:spChg chg="add mod">
          <ac:chgData name="박정우" userId="15c4398f-02bf-4106-9135-a1bc85437f64" providerId="ADAL" clId="{13B7694E-9B31-4718-8A8A-887EDC97A829}" dt="2024-03-16T07:10:28.600" v="61" actId="1076"/>
          <ac:spMkLst>
            <pc:docMk/>
            <pc:sldMk cId="2220921483" sldId="308"/>
            <ac:spMk id="15" creationId="{95F51D5C-88B7-2E57-4B8E-6A03D75FFBC8}"/>
          </ac:spMkLst>
        </pc:spChg>
        <pc:spChg chg="add mod">
          <ac:chgData name="박정우" userId="15c4398f-02bf-4106-9135-a1bc85437f64" providerId="ADAL" clId="{13B7694E-9B31-4718-8A8A-887EDC97A829}" dt="2024-03-16T07:10:33.356" v="63" actId="1076"/>
          <ac:spMkLst>
            <pc:docMk/>
            <pc:sldMk cId="2220921483" sldId="308"/>
            <ac:spMk id="16" creationId="{956E6DC5-3C08-58D4-1BF2-0A4D8FF2A92C}"/>
          </ac:spMkLst>
        </pc:spChg>
        <pc:spChg chg="add mod">
          <ac:chgData name="박정우" userId="15c4398f-02bf-4106-9135-a1bc85437f64" providerId="ADAL" clId="{13B7694E-9B31-4718-8A8A-887EDC97A829}" dt="2024-03-16T07:12:45.471" v="94" actId="12789"/>
          <ac:spMkLst>
            <pc:docMk/>
            <pc:sldMk cId="2220921483" sldId="308"/>
            <ac:spMk id="17" creationId="{CC93E4C7-0A0A-626D-00C9-4182ADE28D01}"/>
          </ac:spMkLst>
        </pc:spChg>
        <pc:spChg chg="add mod">
          <ac:chgData name="박정우" userId="15c4398f-02bf-4106-9135-a1bc85437f64" providerId="ADAL" clId="{13B7694E-9B31-4718-8A8A-887EDC97A829}" dt="2024-03-16T07:12:52.192" v="101" actId="6549"/>
          <ac:spMkLst>
            <pc:docMk/>
            <pc:sldMk cId="2220921483" sldId="308"/>
            <ac:spMk id="18" creationId="{6020EECE-8DEE-AC66-3F21-E5B39DF7BAE5}"/>
          </ac:spMkLst>
        </pc:spChg>
        <pc:picChg chg="add del mod">
          <ac:chgData name="박정우" userId="15c4398f-02bf-4106-9135-a1bc85437f64" providerId="ADAL" clId="{13B7694E-9B31-4718-8A8A-887EDC97A829}" dt="2024-03-16T07:09:54.634" v="50" actId="478"/>
          <ac:picMkLst>
            <pc:docMk/>
            <pc:sldMk cId="2220921483" sldId="308"/>
            <ac:picMk id="4" creationId="{A4A554FA-5AA1-3BFB-E846-A0F26CFC4E90}"/>
          </ac:picMkLst>
        </pc:picChg>
        <pc:picChg chg="add mod">
          <ac:chgData name="박정우" userId="15c4398f-02bf-4106-9135-a1bc85437f64" providerId="ADAL" clId="{13B7694E-9B31-4718-8A8A-887EDC97A829}" dt="2024-03-16T07:09:58.895" v="52" actId="1076"/>
          <ac:picMkLst>
            <pc:docMk/>
            <pc:sldMk cId="2220921483" sldId="308"/>
            <ac:picMk id="5" creationId="{CB5D8B33-E89E-A0FB-B61A-F396986D60EF}"/>
          </ac:picMkLst>
        </pc:picChg>
        <pc:picChg chg="add mod">
          <ac:chgData name="박정우" userId="15c4398f-02bf-4106-9135-a1bc85437f64" providerId="ADAL" clId="{13B7694E-9B31-4718-8A8A-887EDC97A829}" dt="2024-03-16T07:10:00.715" v="53" actId="1076"/>
          <ac:picMkLst>
            <pc:docMk/>
            <pc:sldMk cId="2220921483" sldId="308"/>
            <ac:picMk id="9" creationId="{E9E894C3-D3E5-E7D9-84A9-46BA563B8C29}"/>
          </ac:picMkLst>
        </pc:picChg>
        <pc:picChg chg="add mod">
          <ac:chgData name="박정우" userId="15c4398f-02bf-4106-9135-a1bc85437f64" providerId="ADAL" clId="{13B7694E-9B31-4718-8A8A-887EDC97A829}" dt="2024-03-16T07:12:08.388" v="77" actId="732"/>
          <ac:picMkLst>
            <pc:docMk/>
            <pc:sldMk cId="2220921483" sldId="308"/>
            <ac:picMk id="11" creationId="{BD3D3238-27BD-F868-ECAD-971CFEF3D629}"/>
          </ac:picMkLst>
        </pc:picChg>
      </pc:sldChg>
      <pc:sldChg chg="addSp delSp modSp mod">
        <pc:chgData name="박정우" userId="15c4398f-02bf-4106-9135-a1bc85437f64" providerId="ADAL" clId="{13B7694E-9B31-4718-8A8A-887EDC97A829}" dt="2024-03-16T07:14:15.477" v="115" actId="1076"/>
        <pc:sldMkLst>
          <pc:docMk/>
          <pc:sldMk cId="2268367817" sldId="309"/>
        </pc:sldMkLst>
        <pc:spChg chg="mod">
          <ac:chgData name="박정우" userId="15c4398f-02bf-4106-9135-a1bc85437f64" providerId="ADAL" clId="{13B7694E-9B31-4718-8A8A-887EDC97A829}" dt="2024-03-16T07:11:13.352" v="66" actId="20577"/>
          <ac:spMkLst>
            <pc:docMk/>
            <pc:sldMk cId="2268367817" sldId="309"/>
            <ac:spMk id="2" creationId="{60FA0226-C2CC-D9BE-1749-8CF13DF03B36}"/>
          </ac:spMkLst>
        </pc:spChg>
        <pc:spChg chg="mod">
          <ac:chgData name="박정우" userId="15c4398f-02bf-4106-9135-a1bc85437f64" providerId="ADAL" clId="{13B7694E-9B31-4718-8A8A-887EDC97A829}" dt="2024-03-16T07:11:29.641" v="73" actId="6549"/>
          <ac:spMkLst>
            <pc:docMk/>
            <pc:sldMk cId="2268367817" sldId="309"/>
            <ac:spMk id="3" creationId="{B02AA44C-1EB1-9420-9248-0761150F150D}"/>
          </ac:spMkLst>
        </pc:spChg>
        <pc:spChg chg="add del mod">
          <ac:chgData name="박정우" userId="15c4398f-02bf-4106-9135-a1bc85437f64" providerId="ADAL" clId="{13B7694E-9B31-4718-8A8A-887EDC97A829}" dt="2024-03-16T07:14:11.300" v="114" actId="478"/>
          <ac:spMkLst>
            <pc:docMk/>
            <pc:sldMk cId="2268367817" sldId="309"/>
            <ac:spMk id="5" creationId="{B7A1C799-CC93-AC60-393D-ACB913E06D78}"/>
          </ac:spMkLst>
        </pc:spChg>
        <pc:spChg chg="add mod">
          <ac:chgData name="박정우" userId="15c4398f-02bf-4106-9135-a1bc85437f64" providerId="ADAL" clId="{13B7694E-9B31-4718-8A8A-887EDC97A829}" dt="2024-03-16T07:14:15.477" v="115" actId="1076"/>
          <ac:spMkLst>
            <pc:docMk/>
            <pc:sldMk cId="2268367817" sldId="309"/>
            <ac:spMk id="6" creationId="{B7E4FBD3-6609-D868-51FF-A4A358FFF798}"/>
          </ac:spMkLst>
        </pc:spChg>
        <pc:spChg chg="add mod">
          <ac:chgData name="박정우" userId="15c4398f-02bf-4106-9135-a1bc85437f64" providerId="ADAL" clId="{13B7694E-9B31-4718-8A8A-887EDC97A829}" dt="2024-03-16T07:14:15.477" v="115" actId="1076"/>
          <ac:spMkLst>
            <pc:docMk/>
            <pc:sldMk cId="2268367817" sldId="309"/>
            <ac:spMk id="7" creationId="{3AB3B724-E9CE-C899-13D0-E3C765430859}"/>
          </ac:spMkLst>
        </pc:spChg>
        <pc:spChg chg="add mod">
          <ac:chgData name="박정우" userId="15c4398f-02bf-4106-9135-a1bc85437f64" providerId="ADAL" clId="{13B7694E-9B31-4718-8A8A-887EDC97A829}" dt="2024-03-16T07:14:15.477" v="115" actId="1076"/>
          <ac:spMkLst>
            <pc:docMk/>
            <pc:sldMk cId="2268367817" sldId="309"/>
            <ac:spMk id="8" creationId="{21628781-113E-6E39-DDA4-D21CD9E5CD03}"/>
          </ac:spMkLst>
        </pc:spChg>
        <pc:spChg chg="add mod">
          <ac:chgData name="박정우" userId="15c4398f-02bf-4106-9135-a1bc85437f64" providerId="ADAL" clId="{13B7694E-9B31-4718-8A8A-887EDC97A829}" dt="2024-03-16T07:14:15.477" v="115" actId="1076"/>
          <ac:spMkLst>
            <pc:docMk/>
            <pc:sldMk cId="2268367817" sldId="309"/>
            <ac:spMk id="9" creationId="{0BA9E25F-6EC0-701A-29A9-3F97825CF928}"/>
          </ac:spMkLst>
        </pc:spChg>
        <pc:spChg chg="add mod">
          <ac:chgData name="박정우" userId="15c4398f-02bf-4106-9135-a1bc85437f64" providerId="ADAL" clId="{13B7694E-9B31-4718-8A8A-887EDC97A829}" dt="2024-03-16T07:14:15.477" v="115" actId="1076"/>
          <ac:spMkLst>
            <pc:docMk/>
            <pc:sldMk cId="2268367817" sldId="309"/>
            <ac:spMk id="10" creationId="{5A94630A-1DC8-417C-02E8-7D7DE6A0CAFF}"/>
          </ac:spMkLst>
        </pc:spChg>
        <pc:spChg chg="add mod">
          <ac:chgData name="박정우" userId="15c4398f-02bf-4106-9135-a1bc85437f64" providerId="ADAL" clId="{13B7694E-9B31-4718-8A8A-887EDC97A829}" dt="2024-03-16T07:14:15.477" v="115" actId="1076"/>
          <ac:spMkLst>
            <pc:docMk/>
            <pc:sldMk cId="2268367817" sldId="309"/>
            <ac:spMk id="11" creationId="{6CE7A23A-AE28-B9E2-6F90-6AC946A2610B}"/>
          </ac:spMkLst>
        </pc:spChg>
        <pc:picChg chg="add mod">
          <ac:chgData name="박정우" userId="15c4398f-02bf-4106-9135-a1bc85437f64" providerId="ADAL" clId="{13B7694E-9B31-4718-8A8A-887EDC97A829}" dt="2024-03-16T07:14:15.477" v="115" actId="1076"/>
          <ac:picMkLst>
            <pc:docMk/>
            <pc:sldMk cId="2268367817" sldId="309"/>
            <ac:picMk id="4" creationId="{49062CC3-4E53-FE21-BBF5-4401C5F6EA48}"/>
          </ac:picMkLst>
        </pc:picChg>
      </pc:sldChg>
      <pc:sldChg chg="addSp delSp modSp mod">
        <pc:chgData name="박정우" userId="15c4398f-02bf-4106-9135-a1bc85437f64" providerId="ADAL" clId="{13B7694E-9B31-4718-8A8A-887EDC97A829}" dt="2024-03-16T08:03:49.739" v="218" actId="14100"/>
        <pc:sldMkLst>
          <pc:docMk/>
          <pc:sldMk cId="1130612690" sldId="310"/>
        </pc:sldMkLst>
        <pc:spChg chg="mod">
          <ac:chgData name="박정우" userId="15c4398f-02bf-4106-9135-a1bc85437f64" providerId="ADAL" clId="{13B7694E-9B31-4718-8A8A-887EDC97A829}" dt="2024-03-16T07:15:36.240" v="118" actId="20577"/>
          <ac:spMkLst>
            <pc:docMk/>
            <pc:sldMk cId="1130612690" sldId="310"/>
            <ac:spMk id="2" creationId="{C33D048D-ECB3-84E7-0A9D-0CE732182B09}"/>
          </ac:spMkLst>
        </pc:spChg>
        <pc:spChg chg="mod">
          <ac:chgData name="박정우" userId="15c4398f-02bf-4106-9135-a1bc85437f64" providerId="ADAL" clId="{13B7694E-9B31-4718-8A8A-887EDC97A829}" dt="2024-03-16T07:16:00.491" v="125" actId="6549"/>
          <ac:spMkLst>
            <pc:docMk/>
            <pc:sldMk cId="1130612690" sldId="310"/>
            <ac:spMk id="3" creationId="{42C0AD27-A0C6-C6CB-897B-1F8DC0653B88}"/>
          </ac:spMkLst>
        </pc:spChg>
        <pc:spChg chg="add mod">
          <ac:chgData name="박정우" userId="15c4398f-02bf-4106-9135-a1bc85437f64" providerId="ADAL" clId="{13B7694E-9B31-4718-8A8A-887EDC97A829}" dt="2024-03-16T08:03:19.174" v="210" actId="14100"/>
          <ac:spMkLst>
            <pc:docMk/>
            <pc:sldMk cId="1130612690" sldId="310"/>
            <ac:spMk id="6" creationId="{1209C289-17B6-4AD4-28B7-C83519EDB545}"/>
          </ac:spMkLst>
        </pc:spChg>
        <pc:spChg chg="add del mod">
          <ac:chgData name="박정우" userId="15c4398f-02bf-4106-9135-a1bc85437f64" providerId="ADAL" clId="{13B7694E-9B31-4718-8A8A-887EDC97A829}" dt="2024-03-16T07:18:40.904" v="184" actId="478"/>
          <ac:spMkLst>
            <pc:docMk/>
            <pc:sldMk cId="1130612690" sldId="310"/>
            <ac:spMk id="6" creationId="{F1FCE8AC-7CF2-9024-DBAF-EC5158100C52}"/>
          </ac:spMkLst>
        </pc:spChg>
        <pc:spChg chg="add mod">
          <ac:chgData name="박정우" userId="15c4398f-02bf-4106-9135-a1bc85437f64" providerId="ADAL" clId="{13B7694E-9B31-4718-8A8A-887EDC97A829}" dt="2024-03-16T07:17:50.027" v="154" actId="1076"/>
          <ac:spMkLst>
            <pc:docMk/>
            <pc:sldMk cId="1130612690" sldId="310"/>
            <ac:spMk id="7" creationId="{94ACD4ED-29CC-8EBF-51BC-794AD921CF35}"/>
          </ac:spMkLst>
        </pc:spChg>
        <pc:spChg chg="add del mod">
          <ac:chgData name="박정우" userId="15c4398f-02bf-4106-9135-a1bc85437f64" providerId="ADAL" clId="{13B7694E-9B31-4718-8A8A-887EDC97A829}" dt="2024-03-16T07:18:31.680" v="183" actId="478"/>
          <ac:spMkLst>
            <pc:docMk/>
            <pc:sldMk cId="1130612690" sldId="310"/>
            <ac:spMk id="9" creationId="{713E0926-B0C4-9D92-6DC6-6A85AAEB6B27}"/>
          </ac:spMkLst>
        </pc:spChg>
        <pc:spChg chg="add mod">
          <ac:chgData name="박정우" userId="15c4398f-02bf-4106-9135-a1bc85437f64" providerId="ADAL" clId="{13B7694E-9B31-4718-8A8A-887EDC97A829}" dt="2024-03-16T08:03:28.419" v="213" actId="14100"/>
          <ac:spMkLst>
            <pc:docMk/>
            <pc:sldMk cId="1130612690" sldId="310"/>
            <ac:spMk id="9" creationId="{B5D92A1D-8327-7923-DB52-3E41354F592D}"/>
          </ac:spMkLst>
        </pc:spChg>
        <pc:spChg chg="add mod">
          <ac:chgData name="박정우" userId="15c4398f-02bf-4106-9135-a1bc85437f64" providerId="ADAL" clId="{13B7694E-9B31-4718-8A8A-887EDC97A829}" dt="2024-03-16T07:17:44.708" v="153" actId="255"/>
          <ac:spMkLst>
            <pc:docMk/>
            <pc:sldMk cId="1130612690" sldId="310"/>
            <ac:spMk id="10" creationId="{89CAC795-5472-E692-D534-34EC8199CB42}"/>
          </ac:spMkLst>
        </pc:spChg>
        <pc:spChg chg="add mod">
          <ac:chgData name="박정우" userId="15c4398f-02bf-4106-9135-a1bc85437f64" providerId="ADAL" clId="{13B7694E-9B31-4718-8A8A-887EDC97A829}" dt="2024-03-16T07:18:15.936" v="170" actId="1076"/>
          <ac:spMkLst>
            <pc:docMk/>
            <pc:sldMk cId="1130612690" sldId="310"/>
            <ac:spMk id="11" creationId="{48677D3B-25D4-CAC8-78E0-EA20614FDB72}"/>
          </ac:spMkLst>
        </pc:spChg>
        <pc:spChg chg="add mod">
          <ac:chgData name="박정우" userId="15c4398f-02bf-4106-9135-a1bc85437f64" providerId="ADAL" clId="{13B7694E-9B31-4718-8A8A-887EDC97A829}" dt="2024-03-16T07:18:27.348" v="181" actId="6549"/>
          <ac:spMkLst>
            <pc:docMk/>
            <pc:sldMk cId="1130612690" sldId="310"/>
            <ac:spMk id="12" creationId="{F442B336-0790-4B0A-DD34-77CA83678190}"/>
          </ac:spMkLst>
        </pc:spChg>
        <pc:spChg chg="add mod">
          <ac:chgData name="박정우" userId="15c4398f-02bf-4106-9135-a1bc85437f64" providerId="ADAL" clId="{13B7694E-9B31-4718-8A8A-887EDC97A829}" dt="2024-03-16T08:03:39.924" v="215" actId="1076"/>
          <ac:spMkLst>
            <pc:docMk/>
            <pc:sldMk cId="1130612690" sldId="310"/>
            <ac:spMk id="13" creationId="{9B8AAACB-0EF5-B95C-001E-AB9E8700F392}"/>
          </ac:spMkLst>
        </pc:spChg>
        <pc:spChg chg="add mod">
          <ac:chgData name="박정우" userId="15c4398f-02bf-4106-9135-a1bc85437f64" providerId="ADAL" clId="{13B7694E-9B31-4718-8A8A-887EDC97A829}" dt="2024-03-16T08:03:49.739" v="218" actId="14100"/>
          <ac:spMkLst>
            <pc:docMk/>
            <pc:sldMk cId="1130612690" sldId="310"/>
            <ac:spMk id="14" creationId="{A28D5FE0-4C7A-EC02-0EAB-AFF3548ABAEB}"/>
          </ac:spMkLst>
        </pc:spChg>
        <pc:picChg chg="add mod">
          <ac:chgData name="박정우" userId="15c4398f-02bf-4106-9135-a1bc85437f64" providerId="ADAL" clId="{13B7694E-9B31-4718-8A8A-887EDC97A829}" dt="2024-03-16T07:17:58.043" v="157" actId="1076"/>
          <ac:picMkLst>
            <pc:docMk/>
            <pc:sldMk cId="1130612690" sldId="310"/>
            <ac:picMk id="4" creationId="{A9C9BC24-48D7-AB6F-F78E-09246F61BB68}"/>
          </ac:picMkLst>
        </pc:picChg>
        <pc:picChg chg="add mod">
          <ac:chgData name="박정우" userId="15c4398f-02bf-4106-9135-a1bc85437f64" providerId="ADAL" clId="{13B7694E-9B31-4718-8A8A-887EDC97A829}" dt="2024-03-16T07:16:48.817" v="144" actId="14100"/>
          <ac:picMkLst>
            <pc:docMk/>
            <pc:sldMk cId="1130612690" sldId="310"/>
            <ac:picMk id="5" creationId="{4C953335-92C5-5A35-892A-3D18B8BBA505}"/>
          </ac:picMkLst>
        </pc:picChg>
        <pc:picChg chg="add mod">
          <ac:chgData name="박정우" userId="15c4398f-02bf-4106-9135-a1bc85437f64" providerId="ADAL" clId="{13B7694E-9B31-4718-8A8A-887EDC97A829}" dt="2024-03-16T07:16:51.816" v="146" actId="14100"/>
          <ac:picMkLst>
            <pc:docMk/>
            <pc:sldMk cId="1130612690" sldId="310"/>
            <ac:picMk id="8" creationId="{AD8BAA89-9B19-D44B-DC5A-807D01D77C23}"/>
          </ac:picMkLst>
        </pc:picChg>
      </pc:sldChg>
      <pc:sldChg chg="addSp modSp mod">
        <pc:chgData name="박정우" userId="15c4398f-02bf-4106-9135-a1bc85437f64" providerId="ADAL" clId="{13B7694E-9B31-4718-8A8A-887EDC97A829}" dt="2024-03-16T08:04:04.348" v="223" actId="1076"/>
        <pc:sldMkLst>
          <pc:docMk/>
          <pc:sldMk cId="32352549" sldId="311"/>
        </pc:sldMkLst>
        <pc:spChg chg="mod">
          <ac:chgData name="박정우" userId="15c4398f-02bf-4106-9135-a1bc85437f64" providerId="ADAL" clId="{13B7694E-9B31-4718-8A8A-887EDC97A829}" dt="2024-03-16T07:19:22.169" v="190" actId="20577"/>
          <ac:spMkLst>
            <pc:docMk/>
            <pc:sldMk cId="32352549" sldId="311"/>
            <ac:spMk id="2" creationId="{757C42E9-38A3-F481-0A60-D283120C52D9}"/>
          </ac:spMkLst>
        </pc:spChg>
        <pc:spChg chg="mod">
          <ac:chgData name="박정우" userId="15c4398f-02bf-4106-9135-a1bc85437f64" providerId="ADAL" clId="{13B7694E-9B31-4718-8A8A-887EDC97A829}" dt="2024-03-16T07:19:50.161" v="200" actId="6549"/>
          <ac:spMkLst>
            <pc:docMk/>
            <pc:sldMk cId="32352549" sldId="311"/>
            <ac:spMk id="3" creationId="{7CDD40AF-7936-A286-38A5-A631B0E95097}"/>
          </ac:spMkLst>
        </pc:spChg>
        <pc:spChg chg="add mod">
          <ac:chgData name="박정우" userId="15c4398f-02bf-4106-9135-a1bc85437f64" providerId="ADAL" clId="{13B7694E-9B31-4718-8A8A-887EDC97A829}" dt="2024-03-16T07:20:18.599" v="205" actId="1076"/>
          <ac:spMkLst>
            <pc:docMk/>
            <pc:sldMk cId="32352549" sldId="311"/>
            <ac:spMk id="5" creationId="{8CB9E856-BDBF-B83D-21E3-F49AE67F5846}"/>
          </ac:spMkLst>
        </pc:spChg>
        <pc:spChg chg="add mod">
          <ac:chgData name="박정우" userId="15c4398f-02bf-4106-9135-a1bc85437f64" providerId="ADAL" clId="{13B7694E-9B31-4718-8A8A-887EDC97A829}" dt="2024-03-16T08:03:58.424" v="221" actId="14100"/>
          <ac:spMkLst>
            <pc:docMk/>
            <pc:sldMk cId="32352549" sldId="311"/>
            <ac:spMk id="6" creationId="{F9A88E8B-D63F-7EF3-12F0-676B3A809799}"/>
          </ac:spMkLst>
        </pc:spChg>
        <pc:spChg chg="add mod">
          <ac:chgData name="박정우" userId="15c4398f-02bf-4106-9135-a1bc85437f64" providerId="ADAL" clId="{13B7694E-9B31-4718-8A8A-887EDC97A829}" dt="2024-03-16T08:04:04.348" v="223" actId="1076"/>
          <ac:spMkLst>
            <pc:docMk/>
            <pc:sldMk cId="32352549" sldId="311"/>
            <ac:spMk id="7" creationId="{85986AAE-1414-7447-794E-305018ED7BDF}"/>
          </ac:spMkLst>
        </pc:spChg>
        <pc:picChg chg="add mod">
          <ac:chgData name="박정우" userId="15c4398f-02bf-4106-9135-a1bc85437f64" providerId="ADAL" clId="{13B7694E-9B31-4718-8A8A-887EDC97A829}" dt="2024-03-16T07:19:31.432" v="193" actId="1076"/>
          <ac:picMkLst>
            <pc:docMk/>
            <pc:sldMk cId="32352549" sldId="311"/>
            <ac:picMk id="4" creationId="{3F921A0C-7C03-F7F2-3C5D-67EAA31ECBFF}"/>
          </ac:picMkLst>
        </pc:picChg>
      </pc:sldChg>
      <pc:sldChg chg="del">
        <pc:chgData name="박정우" userId="15c4398f-02bf-4106-9135-a1bc85437f64" providerId="ADAL" clId="{13B7694E-9B31-4718-8A8A-887EDC97A829}" dt="2024-03-16T07:20:48.628" v="207" actId="47"/>
        <pc:sldMkLst>
          <pc:docMk/>
          <pc:sldMk cId="1354510950" sldId="312"/>
        </pc:sldMkLst>
      </pc:sldChg>
      <pc:sldChg chg="del">
        <pc:chgData name="박정우" userId="15c4398f-02bf-4106-9135-a1bc85437f64" providerId="ADAL" clId="{13B7694E-9B31-4718-8A8A-887EDC97A829}" dt="2024-03-16T07:20:48.628" v="207" actId="47"/>
        <pc:sldMkLst>
          <pc:docMk/>
          <pc:sldMk cId="2118335811" sldId="313"/>
        </pc:sldMkLst>
      </pc:sldChg>
      <pc:sldChg chg="del">
        <pc:chgData name="박정우" userId="15c4398f-02bf-4106-9135-a1bc85437f64" providerId="ADAL" clId="{13B7694E-9B31-4718-8A8A-887EDC97A829}" dt="2024-03-16T07:20:48.628" v="207" actId="47"/>
        <pc:sldMkLst>
          <pc:docMk/>
          <pc:sldMk cId="235589801" sldId="314"/>
        </pc:sldMkLst>
      </pc:sldChg>
      <pc:sldChg chg="del">
        <pc:chgData name="박정우" userId="15c4398f-02bf-4106-9135-a1bc85437f64" providerId="ADAL" clId="{13B7694E-9B31-4718-8A8A-887EDC97A829}" dt="2024-03-16T07:20:48.628" v="207" actId="47"/>
        <pc:sldMkLst>
          <pc:docMk/>
          <pc:sldMk cId="3443627793" sldId="315"/>
        </pc:sldMkLst>
      </pc:sldChg>
      <pc:sldChg chg="del">
        <pc:chgData name="박정우" userId="15c4398f-02bf-4106-9135-a1bc85437f64" providerId="ADAL" clId="{13B7694E-9B31-4718-8A8A-887EDC97A829}" dt="2024-03-16T07:20:48.628" v="207" actId="47"/>
        <pc:sldMkLst>
          <pc:docMk/>
          <pc:sldMk cId="3110205435" sldId="316"/>
        </pc:sldMkLst>
      </pc:sldChg>
      <pc:sldChg chg="del">
        <pc:chgData name="박정우" userId="15c4398f-02bf-4106-9135-a1bc85437f64" providerId="ADAL" clId="{13B7694E-9B31-4718-8A8A-887EDC97A829}" dt="2024-03-16T07:20:48.628" v="207" actId="47"/>
        <pc:sldMkLst>
          <pc:docMk/>
          <pc:sldMk cId="451898641" sldId="31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8539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8795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5780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6905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874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5159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649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1451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06945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3791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3972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A45A341-651F-451F-A280-A25018982DEF}" type="datetimeFigureOut">
              <a:rPr lang="ko-KR" altLang="en-US" smtClean="0"/>
              <a:t>2024-03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54F2D8-70DC-4BF0-98C3-B4B7A953F93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681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BFDE053-DC40-54D3-C2E4-4EAC66281D4D}"/>
              </a:ext>
            </a:extLst>
          </p:cNvPr>
          <p:cNvSpPr txBox="1"/>
          <p:nvPr/>
        </p:nvSpPr>
        <p:spPr>
          <a:xfrm>
            <a:off x="310487" y="22567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151FFB62-ECDA-F502-7D98-13309A957D6D}"/>
              </a:ext>
            </a:extLst>
          </p:cNvPr>
          <p:cNvSpPr/>
          <p:nvPr/>
        </p:nvSpPr>
        <p:spPr>
          <a:xfrm>
            <a:off x="4614388" y="2915929"/>
            <a:ext cx="75465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ea typeface="MinionPro-Regular" panose="02040503050201020203" pitchFamily="18" charset="0"/>
                <a:cs typeface="Arial" panose="020B0604020202020204" pitchFamily="34" charset="0"/>
              </a:rPr>
              <a:t>DRG2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C5C9360D-AF1E-38E7-CCA5-27310A57F29C}"/>
              </a:ext>
            </a:extLst>
          </p:cNvPr>
          <p:cNvSpPr/>
          <p:nvPr/>
        </p:nvSpPr>
        <p:spPr>
          <a:xfrm>
            <a:off x="4614388" y="1735307"/>
            <a:ext cx="66306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ea typeface="MinionPro-Regular" panose="02040503050201020203" pitchFamily="18" charset="0"/>
                <a:cs typeface="Arial" panose="020B0604020202020204" pitchFamily="34" charset="0"/>
              </a:rPr>
              <a:t>PD-L1                                                     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20323A75-6E37-A600-3C30-1E387724A21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23" t="16770" r="38423" b="59725"/>
          <a:stretch/>
        </p:blipFill>
        <p:spPr>
          <a:xfrm>
            <a:off x="2601473" y="3806737"/>
            <a:ext cx="1993751" cy="804084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0DE525FE-4B87-39BA-C4DF-D5C7415943C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58" t="69317" r="36147"/>
          <a:stretch/>
        </p:blipFill>
        <p:spPr>
          <a:xfrm>
            <a:off x="2601473" y="1402866"/>
            <a:ext cx="1970527" cy="94188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9B9DCDB-49D2-26AA-43D5-516F8381C644}"/>
              </a:ext>
            </a:extLst>
          </p:cNvPr>
          <p:cNvSpPr txBox="1"/>
          <p:nvPr/>
        </p:nvSpPr>
        <p:spPr>
          <a:xfrm>
            <a:off x="1835151" y="1684267"/>
            <a:ext cx="735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kDa&gt;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A759F6DB-01EB-D17C-0DFB-19DC6C7741D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58" t="18801" r="36147" b="59347"/>
          <a:stretch/>
        </p:blipFill>
        <p:spPr>
          <a:xfrm>
            <a:off x="2601473" y="2716922"/>
            <a:ext cx="1970527" cy="67079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5636F36-EBF0-90B6-A5DF-E8765489F0D8}"/>
              </a:ext>
            </a:extLst>
          </p:cNvPr>
          <p:cNvSpPr txBox="1"/>
          <p:nvPr/>
        </p:nvSpPr>
        <p:spPr>
          <a:xfrm>
            <a:off x="1856005" y="2764524"/>
            <a:ext cx="628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kDa&gt;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91BCC7B-F0EF-78E9-08BE-4F0E8E9B9F47}"/>
              </a:ext>
            </a:extLst>
          </p:cNvPr>
          <p:cNvSpPr txBox="1"/>
          <p:nvPr/>
        </p:nvSpPr>
        <p:spPr>
          <a:xfrm>
            <a:off x="1913156" y="3945217"/>
            <a:ext cx="628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0kDa&gt;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86E6BF2-2F5F-D331-1A10-56DF5895BA72}"/>
              </a:ext>
            </a:extLst>
          </p:cNvPr>
          <p:cNvSpPr txBox="1"/>
          <p:nvPr/>
        </p:nvSpPr>
        <p:spPr>
          <a:xfrm>
            <a:off x="5852162" y="6406444"/>
            <a:ext cx="298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1 for Fig. 1E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2DA5FAA6-769B-CA65-800C-1B471AA8D977}"/>
              </a:ext>
            </a:extLst>
          </p:cNvPr>
          <p:cNvSpPr/>
          <p:nvPr/>
        </p:nvSpPr>
        <p:spPr>
          <a:xfrm>
            <a:off x="2863850" y="1593850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A92E2FBD-DCE2-334B-B95E-54C0FF7BB61F}"/>
              </a:ext>
            </a:extLst>
          </p:cNvPr>
          <p:cNvSpPr/>
          <p:nvPr/>
        </p:nvSpPr>
        <p:spPr>
          <a:xfrm>
            <a:off x="2863850" y="2825512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C8D7376F-7DF0-75ED-C705-A03EC4D62EB2}"/>
              </a:ext>
            </a:extLst>
          </p:cNvPr>
          <p:cNvSpPr/>
          <p:nvPr/>
        </p:nvSpPr>
        <p:spPr>
          <a:xfrm>
            <a:off x="2861674" y="4007730"/>
            <a:ext cx="173355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A5BC1C4-B5E3-B83F-8354-3B0A41FAC48C}"/>
              </a:ext>
            </a:extLst>
          </p:cNvPr>
          <p:cNvSpPr txBox="1"/>
          <p:nvPr/>
        </p:nvSpPr>
        <p:spPr>
          <a:xfrm>
            <a:off x="4614388" y="4096551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01168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B41FED9-C954-C2D3-9F85-85E7D2188534}"/>
              </a:ext>
            </a:extLst>
          </p:cNvPr>
          <p:cNvSpPr txBox="1"/>
          <p:nvPr/>
        </p:nvSpPr>
        <p:spPr>
          <a:xfrm>
            <a:off x="310487" y="22567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4CC1317-8919-1C5F-3AC0-766AF593CEA2}"/>
              </a:ext>
            </a:extLst>
          </p:cNvPr>
          <p:cNvSpPr txBox="1"/>
          <p:nvPr/>
        </p:nvSpPr>
        <p:spPr>
          <a:xfrm>
            <a:off x="5852162" y="6406444"/>
            <a:ext cx="31098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2A for Fig. 2H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0">
            <a:extLst>
              <a:ext uri="{FF2B5EF4-FFF2-40B4-BE49-F238E27FC236}">
                <a16:creationId xmlns:a16="http://schemas.microsoft.com/office/drawing/2014/main" id="{CB5D8B33-E89E-A0FB-B61A-F396986D60E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8359" y="3040128"/>
            <a:ext cx="2256482" cy="13561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10">
            <a:extLst>
              <a:ext uri="{FF2B5EF4-FFF2-40B4-BE49-F238E27FC236}">
                <a16:creationId xmlns:a16="http://schemas.microsoft.com/office/drawing/2014/main" id="{8D2B64D6-EACD-5FB0-1410-7F9A29D0D6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8359" y="1571990"/>
            <a:ext cx="262637" cy="1747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57676" tIns="28838" rIns="57676" bIns="28838" numCol="1" anchor="ctr" anchorCtr="0" compatLnSpc="1">
            <a:prstTxWarp prst="textNoShape">
              <a:avLst/>
            </a:prstTxWarp>
            <a:spAutoFit/>
          </a:bodyPr>
          <a:lstStyle/>
          <a:p>
            <a:pPr defTabSz="57671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757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endParaRPr lang="en-US" altLang="ko-KR" sz="1135" dirty="0">
              <a:latin typeface="Arial" panose="020B0604020202020204" pitchFamily="34" charset="0"/>
            </a:endParaRP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FD35525B-7AD7-C9A8-2EC8-D36455CE8ACE}"/>
              </a:ext>
            </a:extLst>
          </p:cNvPr>
          <p:cNvSpPr/>
          <p:nvPr/>
        </p:nvSpPr>
        <p:spPr>
          <a:xfrm>
            <a:off x="5074770" y="3574799"/>
            <a:ext cx="7773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ea typeface="MinionPro-Regular" panose="02040503050201020203" pitchFamily="18" charset="0"/>
                <a:cs typeface="Arial" panose="020B0604020202020204" pitchFamily="34" charset="0"/>
              </a:rPr>
              <a:t>p-STAT1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E9E894C3-D3E5-E7D9-84A9-46BA563B8C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32586" y="4580141"/>
            <a:ext cx="2339414" cy="1909558"/>
          </a:xfrm>
          <a:prstGeom prst="rect">
            <a:avLst/>
          </a:prstGeom>
        </p:spPr>
      </p:pic>
      <p:pic>
        <p:nvPicPr>
          <p:cNvPr id="11" name="그림 34">
            <a:extLst>
              <a:ext uri="{FF2B5EF4-FFF2-40B4-BE49-F238E27FC236}">
                <a16:creationId xmlns:a16="http://schemas.microsoft.com/office/drawing/2014/main" id="{BD3D3238-27BD-F868-ECAD-971CFEF3D62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909"/>
          <a:stretch/>
        </p:blipFill>
        <p:spPr bwMode="auto">
          <a:xfrm>
            <a:off x="2152806" y="861641"/>
            <a:ext cx="4278350" cy="17990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A0A594F-28FA-7241-A4A1-64B56AF6C6B2}"/>
              </a:ext>
            </a:extLst>
          </p:cNvPr>
          <p:cNvSpPr txBox="1"/>
          <p:nvPr/>
        </p:nvSpPr>
        <p:spPr>
          <a:xfrm>
            <a:off x="4608602" y="5440871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23A7333D-BFB4-7E0C-D2F7-E0D1FC4B2358}"/>
              </a:ext>
            </a:extLst>
          </p:cNvPr>
          <p:cNvSpPr/>
          <p:nvPr/>
        </p:nvSpPr>
        <p:spPr>
          <a:xfrm>
            <a:off x="2730500" y="1379320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EFE44549-5DDE-1835-C3B6-D5337E759893}"/>
              </a:ext>
            </a:extLst>
          </p:cNvPr>
          <p:cNvSpPr/>
          <p:nvPr/>
        </p:nvSpPr>
        <p:spPr>
          <a:xfrm>
            <a:off x="4439306" y="1746736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95F51D5C-88B7-2E57-4B8E-6A03D75FFBC8}"/>
              </a:ext>
            </a:extLst>
          </p:cNvPr>
          <p:cNvSpPr/>
          <p:nvPr/>
        </p:nvSpPr>
        <p:spPr>
          <a:xfrm>
            <a:off x="2883556" y="3478995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956E6DC5-3C08-58D4-1BF2-0A4D8FF2A92C}"/>
              </a:ext>
            </a:extLst>
          </p:cNvPr>
          <p:cNvSpPr/>
          <p:nvPr/>
        </p:nvSpPr>
        <p:spPr>
          <a:xfrm>
            <a:off x="2844837" y="5429699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CC93E4C7-0A0A-626D-00C9-4182ADE28D01}"/>
              </a:ext>
            </a:extLst>
          </p:cNvPr>
          <p:cNvSpPr/>
          <p:nvPr/>
        </p:nvSpPr>
        <p:spPr>
          <a:xfrm>
            <a:off x="3136912" y="581027"/>
            <a:ext cx="6190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ea typeface="MinionPro-Regular" panose="02040503050201020203" pitchFamily="18" charset="0"/>
                <a:cs typeface="Arial" panose="020B0604020202020204" pitchFamily="34" charset="0"/>
              </a:rPr>
              <a:t>PD-L1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6020EECE-8DEE-AC66-3F21-E5B39DF7BAE5}"/>
              </a:ext>
            </a:extLst>
          </p:cNvPr>
          <p:cNvSpPr/>
          <p:nvPr/>
        </p:nvSpPr>
        <p:spPr>
          <a:xfrm>
            <a:off x="4961616" y="581027"/>
            <a:ext cx="6110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ea typeface="MinionPro-Regular" panose="02040503050201020203" pitchFamily="18" charset="0"/>
                <a:cs typeface="Arial" panose="020B0604020202020204" pitchFamily="34" charset="0"/>
              </a:rPr>
              <a:t>DRG2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09214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0FA0226-C2CC-D9BE-1749-8CF13DF03B36}"/>
              </a:ext>
            </a:extLst>
          </p:cNvPr>
          <p:cNvSpPr txBox="1"/>
          <p:nvPr/>
        </p:nvSpPr>
        <p:spPr>
          <a:xfrm>
            <a:off x="310487" y="22567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02AA44C-1EB1-9420-9248-0761150F150D}"/>
              </a:ext>
            </a:extLst>
          </p:cNvPr>
          <p:cNvSpPr txBox="1"/>
          <p:nvPr/>
        </p:nvSpPr>
        <p:spPr>
          <a:xfrm>
            <a:off x="5852162" y="6406444"/>
            <a:ext cx="30893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2B for Fig. 2L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49062CC3-4E53-FE21-BBF5-4401C5F6EA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8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52468" y="2442784"/>
            <a:ext cx="6914869" cy="1678366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B7E4FBD3-6609-D868-51FF-A4A358FFF798}"/>
              </a:ext>
            </a:extLst>
          </p:cNvPr>
          <p:cNvSpPr/>
          <p:nvPr/>
        </p:nvSpPr>
        <p:spPr>
          <a:xfrm>
            <a:off x="2476500" y="3157320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3AB3B724-E9CE-C899-13D0-E3C765430859}"/>
              </a:ext>
            </a:extLst>
          </p:cNvPr>
          <p:cNvSpPr/>
          <p:nvPr/>
        </p:nvSpPr>
        <p:spPr>
          <a:xfrm>
            <a:off x="4399527" y="3098259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21628781-113E-6E39-DDA4-D21CD9E5CD03}"/>
              </a:ext>
            </a:extLst>
          </p:cNvPr>
          <p:cNvSpPr/>
          <p:nvPr/>
        </p:nvSpPr>
        <p:spPr>
          <a:xfrm>
            <a:off x="6355409" y="3276790"/>
            <a:ext cx="166370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A9E25F-6EC0-701A-29A9-3F97825CF928}"/>
              </a:ext>
            </a:extLst>
          </p:cNvPr>
          <p:cNvSpPr txBox="1"/>
          <p:nvPr/>
        </p:nvSpPr>
        <p:spPr>
          <a:xfrm>
            <a:off x="2990862" y="2165785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5A94630A-1DC8-417C-02E8-7D7DE6A0CAFF}"/>
              </a:ext>
            </a:extLst>
          </p:cNvPr>
          <p:cNvSpPr/>
          <p:nvPr/>
        </p:nvSpPr>
        <p:spPr>
          <a:xfrm>
            <a:off x="4921837" y="2165784"/>
            <a:ext cx="6190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ea typeface="MinionPro-Regular" panose="02040503050201020203" pitchFamily="18" charset="0"/>
                <a:cs typeface="Arial" panose="020B0604020202020204" pitchFamily="34" charset="0"/>
              </a:rPr>
              <a:t>PD-L1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6CE7A23A-AE28-B9E2-6F90-6AC946A2610B}"/>
              </a:ext>
            </a:extLst>
          </p:cNvPr>
          <p:cNvSpPr/>
          <p:nvPr/>
        </p:nvSpPr>
        <p:spPr>
          <a:xfrm>
            <a:off x="6823958" y="2165784"/>
            <a:ext cx="6110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ea typeface="MinionPro-Regular" panose="02040503050201020203" pitchFamily="18" charset="0"/>
                <a:cs typeface="Arial" panose="020B0604020202020204" pitchFamily="34" charset="0"/>
              </a:rPr>
              <a:t>DRG2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83678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33D048D-ECB3-84E7-0A9D-0CE732182B09}"/>
              </a:ext>
            </a:extLst>
          </p:cNvPr>
          <p:cNvSpPr txBox="1"/>
          <p:nvPr/>
        </p:nvSpPr>
        <p:spPr>
          <a:xfrm>
            <a:off x="310487" y="22567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3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2C0AD27-A0C6-C6CB-897B-1F8DC0653B88}"/>
              </a:ext>
            </a:extLst>
          </p:cNvPr>
          <p:cNvSpPr txBox="1"/>
          <p:nvPr/>
        </p:nvSpPr>
        <p:spPr>
          <a:xfrm>
            <a:off x="5852162" y="6406444"/>
            <a:ext cx="31197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3 for Fig. S3C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8">
            <a:extLst>
              <a:ext uri="{FF2B5EF4-FFF2-40B4-BE49-F238E27FC236}">
                <a16:creationId xmlns:a16="http://schemas.microsoft.com/office/drawing/2014/main" id="{A9C9BC24-48D7-AB6F-F78E-09246F61BB6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178"/>
          <a:stretch/>
        </p:blipFill>
        <p:spPr bwMode="auto">
          <a:xfrm>
            <a:off x="2119968" y="1331232"/>
            <a:ext cx="5238767" cy="21385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그림 39">
            <a:extLst>
              <a:ext uri="{FF2B5EF4-FFF2-40B4-BE49-F238E27FC236}">
                <a16:creationId xmlns:a16="http://schemas.microsoft.com/office/drawing/2014/main" id="{4C953335-92C5-5A35-892A-3D18B8BBA5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7740" y="4015178"/>
            <a:ext cx="2733813" cy="17442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직사각형 6">
            <a:extLst>
              <a:ext uri="{FF2B5EF4-FFF2-40B4-BE49-F238E27FC236}">
                <a16:creationId xmlns:a16="http://schemas.microsoft.com/office/drawing/2014/main" id="{94ACD4ED-29CC-8EBF-51BC-794AD921CF35}"/>
              </a:ext>
            </a:extLst>
          </p:cNvPr>
          <p:cNvSpPr/>
          <p:nvPr/>
        </p:nvSpPr>
        <p:spPr>
          <a:xfrm>
            <a:off x="2918248" y="3703251"/>
            <a:ext cx="7773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AD8BAA89-9B19-D44B-DC5A-807D01D77C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43878" y="3957789"/>
            <a:ext cx="2387272" cy="176625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9CAC795-5472-E692-D534-34EC8199CB42}"/>
              </a:ext>
            </a:extLst>
          </p:cNvPr>
          <p:cNvSpPr txBox="1"/>
          <p:nvPr/>
        </p:nvSpPr>
        <p:spPr>
          <a:xfrm>
            <a:off x="6850152" y="366980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48677D3B-25D4-CAC8-78E0-EA20614FDB72}"/>
              </a:ext>
            </a:extLst>
          </p:cNvPr>
          <p:cNvSpPr/>
          <p:nvPr/>
        </p:nvSpPr>
        <p:spPr>
          <a:xfrm>
            <a:off x="2918248" y="1019305"/>
            <a:ext cx="6110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RG2</a:t>
            </a: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F442B336-0790-4B0A-DD34-77CA83678190}"/>
              </a:ext>
            </a:extLst>
          </p:cNvPr>
          <p:cNvSpPr/>
          <p:nvPr/>
        </p:nvSpPr>
        <p:spPr>
          <a:xfrm>
            <a:off x="5003624" y="1019305"/>
            <a:ext cx="6190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1209C289-17B6-4AD4-28B7-C83519EDB545}"/>
              </a:ext>
            </a:extLst>
          </p:cNvPr>
          <p:cNvSpPr/>
          <p:nvPr/>
        </p:nvSpPr>
        <p:spPr>
          <a:xfrm>
            <a:off x="2279650" y="2400491"/>
            <a:ext cx="1746250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B5D92A1D-8327-7923-DB52-3E41354F592D}"/>
              </a:ext>
            </a:extLst>
          </p:cNvPr>
          <p:cNvSpPr/>
          <p:nvPr/>
        </p:nvSpPr>
        <p:spPr>
          <a:xfrm>
            <a:off x="4440038" y="1924241"/>
            <a:ext cx="2005211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9B8AAACB-0EF5-B95C-001E-AB9E8700F392}"/>
              </a:ext>
            </a:extLst>
          </p:cNvPr>
          <p:cNvSpPr/>
          <p:nvPr/>
        </p:nvSpPr>
        <p:spPr>
          <a:xfrm>
            <a:off x="2221174" y="4657210"/>
            <a:ext cx="2005211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A28D5FE0-4C7A-EC02-0EAB-AFF3548ABAEB}"/>
              </a:ext>
            </a:extLst>
          </p:cNvPr>
          <p:cNvSpPr/>
          <p:nvPr/>
        </p:nvSpPr>
        <p:spPr>
          <a:xfrm>
            <a:off x="6356129" y="4703606"/>
            <a:ext cx="1498821" cy="3674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06126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57C42E9-38A3-F481-0A60-D283120C52D9}"/>
              </a:ext>
            </a:extLst>
          </p:cNvPr>
          <p:cNvSpPr txBox="1"/>
          <p:nvPr/>
        </p:nvSpPr>
        <p:spPr>
          <a:xfrm>
            <a:off x="310487" y="225673"/>
            <a:ext cx="2752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ko-KR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Material 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CDD40AF-7936-A286-38A5-A631B0E95097}"/>
              </a:ext>
            </a:extLst>
          </p:cNvPr>
          <p:cNvSpPr txBox="1"/>
          <p:nvPr/>
        </p:nvSpPr>
        <p:spPr>
          <a:xfrm>
            <a:off x="5852162" y="6406444"/>
            <a:ext cx="2989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 4 for Fig. 3E</a:t>
            </a:r>
            <a:endParaRPr kumimoji="1"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21">
            <a:extLst>
              <a:ext uri="{FF2B5EF4-FFF2-40B4-BE49-F238E27FC236}">
                <a16:creationId xmlns:a16="http://schemas.microsoft.com/office/drawing/2014/main" id="{3F921A0C-7C03-F7F2-3C5D-67EAA31ECBF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1229" y="1827670"/>
            <a:ext cx="4380440" cy="29665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8CB9E856-BDBF-B83D-21E3-F49AE67F5846}"/>
              </a:ext>
            </a:extLst>
          </p:cNvPr>
          <p:cNvSpPr/>
          <p:nvPr/>
        </p:nvSpPr>
        <p:spPr>
          <a:xfrm>
            <a:off x="6471669" y="3033961"/>
            <a:ext cx="6190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200" dirty="0">
                <a:latin typeface="Arial" panose="020B0604020202020204" pitchFamily="34" charset="0"/>
                <a:ea typeface="MinionPro-Regular" panose="02040503050201020203" pitchFamily="18" charset="0"/>
                <a:cs typeface="Arial" panose="020B0604020202020204" pitchFamily="34" charset="0"/>
              </a:rPr>
              <a:t>PD-L1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F9A88E8B-D63F-7EF3-12F0-676B3A809799}"/>
              </a:ext>
            </a:extLst>
          </p:cNvPr>
          <p:cNvSpPr/>
          <p:nvPr/>
        </p:nvSpPr>
        <p:spPr>
          <a:xfrm>
            <a:off x="2276238" y="2988752"/>
            <a:ext cx="2005211" cy="7958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85986AAE-1414-7447-794E-305018ED7BDF}"/>
              </a:ext>
            </a:extLst>
          </p:cNvPr>
          <p:cNvSpPr/>
          <p:nvPr/>
        </p:nvSpPr>
        <p:spPr>
          <a:xfrm>
            <a:off x="4362802" y="2988752"/>
            <a:ext cx="2005211" cy="7958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52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76</Words>
  <Application>Microsoft Office PowerPoint</Application>
  <PresentationFormat>화면 슬라이드 쇼(4:3)</PresentationFormat>
  <Paragraphs>29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정우</dc:creator>
  <cp:lastModifiedBy>박정우</cp:lastModifiedBy>
  <cp:revision>1</cp:revision>
  <dcterms:created xsi:type="dcterms:W3CDTF">2024-03-16T06:49:26Z</dcterms:created>
  <dcterms:modified xsi:type="dcterms:W3CDTF">2024-03-16T08:04:05Z</dcterms:modified>
</cp:coreProperties>
</file>